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09728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4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36" y="-1212"/>
      </p:cViewPr>
      <p:guideLst>
        <p:guide orient="horz" pos="2160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F6BCB7-CA19-4C5E-9F2E-6B02DF7D6F3E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685800"/>
            <a:ext cx="5486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32F9D0-DDBF-4179-984E-53B1C45F4E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882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32F9D0-DDBF-4179-984E-53B1C45F4EF8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959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130428"/>
            <a:ext cx="932688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3886200"/>
            <a:ext cx="768096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088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899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5280" y="274641"/>
            <a:ext cx="246888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8640" y="274641"/>
            <a:ext cx="722376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353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1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4406903"/>
            <a:ext cx="932688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2906713"/>
            <a:ext cx="932688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441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8640" y="1600203"/>
            <a:ext cx="484632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7840" y="1600203"/>
            <a:ext cx="484632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386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1" y="1535113"/>
            <a:ext cx="484822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1" y="2174875"/>
            <a:ext cx="484822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1" y="1535113"/>
            <a:ext cx="485013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1" y="2174875"/>
            <a:ext cx="485013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405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754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59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1" y="273050"/>
            <a:ext cx="360997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273053"/>
            <a:ext cx="61341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1" y="1435103"/>
            <a:ext cx="360997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958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5" y="4800600"/>
            <a:ext cx="658368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5" y="612775"/>
            <a:ext cx="658368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5" y="5367338"/>
            <a:ext cx="658368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2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274638"/>
            <a:ext cx="987552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1600203"/>
            <a:ext cx="987552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6356353"/>
            <a:ext cx="2560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E8DCB-D970-4313-8517-5F19BC53D29A}" type="datetimeFigureOut">
              <a:rPr lang="en-US" smtClean="0"/>
              <a:pPr/>
              <a:t>1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6356353"/>
            <a:ext cx="34747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6356353"/>
            <a:ext cx="2560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B3B10-FD79-4016-BA0F-9CCD61ADDB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914400" y="381000"/>
            <a:ext cx="9408941" cy="5257228"/>
            <a:chOff x="919916" y="1459051"/>
            <a:chExt cx="9408941" cy="5257228"/>
          </a:xfrm>
        </p:grpSpPr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8550" y="1683238"/>
              <a:ext cx="6950307" cy="50330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919916" y="1683238"/>
              <a:ext cx="2281394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Human AQP5</a:t>
              </a:r>
            </a:p>
            <a:p>
              <a:pPr algn="just"/>
              <a:r>
                <a:rPr lang="en-US" sz="1100" dirty="0" err="1">
                  <a:latin typeface="Arial Narrow" pitchFamily="34" charset="0"/>
                  <a:cs typeface="Courier New" panose="02070309020205020404" pitchFamily="49" charset="0"/>
                </a:rPr>
                <a:t>Prevotella</a:t>
              </a:r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 nanceiensis                          </a:t>
              </a:r>
            </a:p>
            <a:p>
              <a:pPr algn="just"/>
              <a:r>
                <a:rPr lang="en-US" sz="1100" dirty="0" err="1">
                  <a:latin typeface="Arial Narrow" pitchFamily="34" charset="0"/>
                  <a:cs typeface="Courier New" panose="02070309020205020404" pitchFamily="49" charset="0"/>
                </a:rPr>
                <a:t>Neisseria</a:t>
              </a:r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 mucos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Neisseria subflav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arasanguinis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seudopneumoniae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oralis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histicola                        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melaninogenica            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771317" y="1815447"/>
              <a:ext cx="755335" cy="1446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3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9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3%/51%)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4%/53%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19916" y="3392596"/>
              <a:ext cx="2281394" cy="1615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Human AQP5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nanceiensis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Neisseria mucos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Neisseria subflav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arasanguinis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seudopneumoniae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oralis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histicola                        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melaninogenica            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771317" y="3537311"/>
              <a:ext cx="755335" cy="1446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3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9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3%/51%)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4%/53%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19916" y="5099733"/>
              <a:ext cx="2281394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Human AQP5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nanceiensis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Neisseria mucos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Neisseria subflava             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arasanguinis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pseudopneumoniae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Streptococcus oralis                       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histicola                        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Prevotella melaninogenica            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771317" y="5221395"/>
              <a:ext cx="755335" cy="1446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3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6%/54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9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8%/57%)</a:t>
              </a:r>
            </a:p>
            <a:p>
              <a:pPr algn="jus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3%/51%)</a:t>
              </a:r>
            </a:p>
            <a:p>
              <a:pPr algn="just" fontAlgn="t"/>
              <a:r>
                <a:rPr lang="en-US" sz="1100" dirty="0">
                  <a:latin typeface="Arial Narrow" pitchFamily="34" charset="0"/>
                  <a:cs typeface="Courier New" panose="02070309020205020404" pitchFamily="49" charset="0"/>
                </a:rPr>
                <a:t>(34%/53%)</a:t>
              </a:r>
            </a:p>
          </p:txBody>
        </p:sp>
        <p:grpSp>
          <p:nvGrpSpPr>
            <p:cNvPr id="39" name="그룹 38"/>
            <p:cNvGrpSpPr/>
            <p:nvPr/>
          </p:nvGrpSpPr>
          <p:grpSpPr>
            <a:xfrm>
              <a:off x="3447032" y="1459051"/>
              <a:ext cx="6534589" cy="5165115"/>
              <a:chOff x="2532631" y="1459050"/>
              <a:chExt cx="6534589" cy="5165115"/>
            </a:xfrm>
          </p:grpSpPr>
          <p:sp>
            <p:nvSpPr>
              <p:cNvPr id="21" name="직사각형 20"/>
              <p:cNvSpPr/>
              <p:nvPr/>
            </p:nvSpPr>
            <p:spPr>
              <a:xfrm>
                <a:off x="5011749" y="1712767"/>
                <a:ext cx="509551" cy="148414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2" name="직사각형 21"/>
              <p:cNvSpPr/>
              <p:nvPr/>
            </p:nvSpPr>
            <p:spPr>
              <a:xfrm>
                <a:off x="7395969" y="1702346"/>
                <a:ext cx="1664270" cy="149456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898880" y="1466030"/>
                <a:ext cx="74866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>
                    <a:latin typeface="Times New Roman" pitchFamily="18" charset="0"/>
                    <a:cs typeface="Times New Roman" pitchFamily="18" charset="0"/>
                  </a:rPr>
                  <a:t>Loop A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직사각형 23"/>
              <p:cNvSpPr/>
              <p:nvPr/>
            </p:nvSpPr>
            <p:spPr>
              <a:xfrm>
                <a:off x="7875233" y="1459050"/>
                <a:ext cx="74892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b="1" dirty="0">
                    <a:latin typeface="Times New Roman" pitchFamily="18" charset="0"/>
                    <a:cs typeface="Times New Roman" pitchFamily="18" charset="0"/>
                  </a:rPr>
                  <a:t>Loop B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직사각형 25"/>
              <p:cNvSpPr/>
              <p:nvPr/>
            </p:nvSpPr>
            <p:spPr>
              <a:xfrm>
                <a:off x="2532631" y="3435701"/>
                <a:ext cx="378093" cy="148414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28" name="직선 연결선 27"/>
              <p:cNvCxnSpPr/>
              <p:nvPr/>
            </p:nvCxnSpPr>
            <p:spPr>
              <a:xfrm flipH="1">
                <a:off x="2533795" y="3413295"/>
                <a:ext cx="6981" cy="1521673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직선 연결선 29"/>
              <p:cNvCxnSpPr/>
              <p:nvPr/>
            </p:nvCxnSpPr>
            <p:spPr>
              <a:xfrm flipH="1">
                <a:off x="9060239" y="1701994"/>
                <a:ext cx="6981" cy="1521673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직사각형 30"/>
              <p:cNvSpPr/>
              <p:nvPr/>
            </p:nvSpPr>
            <p:spPr>
              <a:xfrm>
                <a:off x="4209032" y="3441366"/>
                <a:ext cx="2170828" cy="147964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2" name="직사각형 31"/>
              <p:cNvSpPr/>
              <p:nvPr/>
            </p:nvSpPr>
            <p:spPr>
              <a:xfrm>
                <a:off x="7819642" y="3441367"/>
                <a:ext cx="793866" cy="147266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950496" y="3200071"/>
                <a:ext cx="7585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>
                    <a:latin typeface="Times New Roman" pitchFamily="18" charset="0"/>
                    <a:cs typeface="Times New Roman" pitchFamily="18" charset="0"/>
                  </a:rPr>
                  <a:t>Loop C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7824083" y="3196769"/>
                <a:ext cx="7585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>
                    <a:latin typeface="Times New Roman" pitchFamily="18" charset="0"/>
                    <a:cs typeface="Times New Roman" pitchFamily="18" charset="0"/>
                  </a:rPr>
                  <a:t>Loop D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" name="직사각형 34"/>
              <p:cNvSpPr/>
              <p:nvPr/>
            </p:nvSpPr>
            <p:spPr>
              <a:xfrm>
                <a:off x="3544764" y="5135399"/>
                <a:ext cx="2325544" cy="148876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332185" y="4903228"/>
                <a:ext cx="74892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>
                    <a:latin typeface="Times New Roman" pitchFamily="18" charset="0"/>
                    <a:cs typeface="Times New Roman" pitchFamily="18" charset="0"/>
                  </a:rPr>
                  <a:t>Loop E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5" name="직사각형 4"/>
          <p:cNvSpPr/>
          <p:nvPr/>
        </p:nvSpPr>
        <p:spPr>
          <a:xfrm>
            <a:off x="914400" y="5816679"/>
            <a:ext cx="915460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 Sequence alignment of selected bacterial AQP proteins and human AQP5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s in parentheses indicate percentages of identical and conserved amino acids. Identical and conserved amino acids are highlighted with dark gray and light gray, respectively.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7574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2</TotalTime>
  <Words>228</Words>
  <Application>Microsoft Office PowerPoint</Application>
  <PresentationFormat>사용자 지정</PresentationFormat>
  <Paragraphs>5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Arial Narrow</vt:lpstr>
      <vt:lpstr>Calibri</vt:lpstr>
      <vt:lpstr>Courier New</vt:lpstr>
      <vt:lpstr>Times New Roman</vt:lpstr>
      <vt:lpstr>Office Them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han_Alam</dc:creator>
  <cp:lastModifiedBy>최영님</cp:lastModifiedBy>
  <cp:revision>17</cp:revision>
  <dcterms:created xsi:type="dcterms:W3CDTF">2015-04-29T00:31:13Z</dcterms:created>
  <dcterms:modified xsi:type="dcterms:W3CDTF">2015-12-19T05:53:54Z</dcterms:modified>
</cp:coreProperties>
</file>